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17EF8A-9CBA-FD54-285C-6FEFE932B8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136FA8C-D5C8-1386-3DA2-B1DAF88CA0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116FF5-78D6-C388-996D-0C7AB8896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886FB19-321F-0AB6-F825-894730590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08499FF-A872-F9BA-AA72-D9A9C7F18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1676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762BAD9-3D75-16A7-18DB-87F05AB0E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9963358-84B8-CB3F-64F8-997EFAE53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E89DEE5-67C4-C123-6CBE-C166A7388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C41AA1-6721-C72D-C882-28AAF17E4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8864C39-3CD1-9A80-9A60-28B5F959E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38904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48365BD-683A-6ABD-C1C2-3DDD5582C2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97F2FBC-1148-0D5A-4172-EDE11DADBE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57036F-4F9D-CF6F-7C59-98BE061B5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7791B7-A932-3442-4779-80EDAACF1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0524AB2-20AE-193D-A130-33A57027E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23761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75B7D1-41DE-A418-3159-0A1365B0E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E6FE6D0-25CF-8006-C5F1-FD92C6C65C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85266A-6821-89E6-C4CD-DAFE2F5CD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819FD85-CC5E-C3E2-E000-22C866C7B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463883-6AD6-D0B8-A41F-5F9D62304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75383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32D6D2C-10D6-BE6F-B98F-0B157C0144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DDF133B-C1ED-60B6-226F-F3CB2D74DA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11790A8-40F3-7E84-F59A-F9B4FCAD7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429B9E0-2D8B-17D8-539F-1C09E9CF8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61495BE-4F6E-684E-CC67-241B1383A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9364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E0EA26A-AB2B-636D-B6F5-5ADE168D9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169417F-463E-280B-50AA-BEE9A124BF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064340B-3975-A076-FB63-97C85CBA4C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E37DCE6-06D8-A55A-4B63-064CDC8CF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1599C02-57CA-5653-6C22-91C9A7DF8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902D1F4-C813-CD1B-2493-0862CF125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09453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866A4B-9ED0-973E-27C7-CD76D9CC45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B7132EB-60E5-1224-46B7-97DCA05038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856005F-151E-B2A2-DD5D-BEA5C2AB49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2E4241B-5108-F13D-379D-CC68E1856F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76B538E-FC79-ADE7-222E-43B593127B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B901316-41FD-24CE-8FF1-3431DE0FE7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9CCFDFE-EC8E-B4EA-2180-5BF5BF3E1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F2CE217-4599-224F-7E07-28917A45F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43604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A78C42-7D1A-475B-BCE0-FAF4FE608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5FA5ACB-F390-BBB6-275F-63FA06458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964C557-FE0E-A62F-9937-8B61AFFDB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C180AC5-FA9A-6F77-55A2-6AFB57BD1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8865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D6EFB38-19B7-2CE5-F16A-EEDBA1F7F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0B3EA58-853C-9B91-26C7-F3027377C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0BA18B1-8310-7D9D-71A1-887F840AD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56106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B4DE857-46AD-764C-9BE3-F2127DD7E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41058FA-51E6-EC1F-02C0-2937FC1F24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DFB27A7-5BFE-94A1-9B7E-B959111DCD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CCE36A8-D4B1-356A-FB6A-9DD617F5D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0D0F936-082A-DD0A-4FD4-3873E61CB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B50EC4C-604D-80F6-D300-8FCB5083D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794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9D537A-A064-6F80-6746-EB71AB9D9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1C294A4-8049-8E4D-BB2C-9193ED7226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FFDEC29-4B98-A62D-33E0-0E4BE5E21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FDC6007-7071-FF0E-FBDC-5A7D46B8A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540A189-CF6E-8B96-B9A8-7A65A002F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1E17C01-9FAD-9C8A-0AF6-06E2141B1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11700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2729E3E-6266-F013-B5D6-315D50FC5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2B34C93-2599-34C8-3511-AB66AD42CA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10FBE61-DE5F-953B-84F5-1E9AC2B293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D5C10D6-C49C-4D29-9277-7760C5C0E844}" type="datetimeFigureOut">
              <a:rPr lang="de-CH" smtClean="0"/>
              <a:t>30.12.2025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C8C0AE4-090C-638E-CE9A-733625252C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2A4C22-869A-A49C-5688-3E525D5FBE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63B912-1233-4ADF-8F21-1BC283782F4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22520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E68E8DA-88B4-419C-FF7E-7675426A1D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7760" y="937895"/>
            <a:ext cx="4856480" cy="498221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F2D0E073-D01E-362F-06AB-A5A2293D6F6E}"/>
              </a:ext>
            </a:extLst>
          </p:cNvPr>
          <p:cNvSpPr txBox="1"/>
          <p:nvPr/>
        </p:nvSpPr>
        <p:spPr>
          <a:xfrm>
            <a:off x="248479" y="6402675"/>
            <a:ext cx="609467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: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lowchart of the study population. 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223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CF352E9-B5CF-9584-81D8-5122A16521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116" y="794077"/>
            <a:ext cx="9608551" cy="5157544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E4DF739-1206-8A75-8B75-64711E1B2740}"/>
              </a:ext>
            </a:extLst>
          </p:cNvPr>
          <p:cNvSpPr txBox="1"/>
          <p:nvPr/>
        </p:nvSpPr>
        <p:spPr>
          <a:xfrm>
            <a:off x="503304" y="6355459"/>
            <a:ext cx="609467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: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variate balance before matching (red) and after matching (blue).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89462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673">
            <a:extLst>
              <a:ext uri="{FF2B5EF4-FFF2-40B4-BE49-F238E27FC236}">
                <a16:creationId xmlns:a16="http://schemas.microsoft.com/office/drawing/2014/main" id="{10BBA33B-FF37-6D80-B200-0091ED6C472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366838" y="541141"/>
            <a:ext cx="7760474" cy="5249849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B1B2B54-BDB0-D0C5-38C2-1F0E3EDBE07C}"/>
              </a:ext>
            </a:extLst>
          </p:cNvPr>
          <p:cNvSpPr txBox="1"/>
          <p:nvPr/>
        </p:nvSpPr>
        <p:spPr>
          <a:xfrm>
            <a:off x="429370" y="5790990"/>
            <a:ext cx="11333259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: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o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abolic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rameter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 the propensity score-matched population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eiving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trat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)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eiving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trat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NC)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lin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s.</a:t>
            </a:r>
            <a:r>
              <a:rPr lang="en-GB" sz="1400" spc="10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s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.</a:t>
            </a:r>
            <a:r>
              <a:rPr lang="en-GB" sz="1400" spc="5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=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thropometric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dices,</a:t>
            </a:r>
            <a:r>
              <a:rPr lang="en-GB" sz="1400" spc="-3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=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lucose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abolism,</a:t>
            </a:r>
            <a:r>
              <a:rPr lang="en-GB" sz="1400" spc="-3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=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pid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abolism.</a:t>
            </a:r>
            <a:r>
              <a:rPr lang="en-GB" sz="1400" spc="5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ttom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</a:t>
            </a:r>
            <a:r>
              <a:rPr lang="en-GB" sz="1400" spc="-4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spc="-1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xplot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fers to the number of patients included per time point and group. BMI, body mass index; BRI, body roundness index; C, citrate group; HbA1c, </a:t>
            </a:r>
            <a:r>
              <a:rPr lang="en-GB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moglobin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1c; HDL, high-density lipoprotein cholesterol; LDL, low-density lipoprotein cholesterol; NC, non-citrate group.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94397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0CD2F3D2-5D14-AF6E-6521-A73005A74B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3729" y="479949"/>
            <a:ext cx="8030816" cy="5353877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70CA94DC-6EB2-28E7-4B12-8DD743E658BB}"/>
              </a:ext>
            </a:extLst>
          </p:cNvPr>
          <p:cNvSpPr txBox="1"/>
          <p:nvPr/>
        </p:nvSpPr>
        <p:spPr>
          <a:xfrm>
            <a:off x="310264" y="6100538"/>
            <a:ext cx="114498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31115" algn="just"/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</a:t>
            </a:r>
            <a:r>
              <a:rPr lang="en-GB" sz="1400" b="1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4: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lot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4-h-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rine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rameters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eiving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trate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)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t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eiving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itrate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NC)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aseline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s. 1</a:t>
            </a:r>
            <a:r>
              <a:rPr lang="en-GB" sz="1400" spc="-4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 and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. Th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ttom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xplo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fer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en-GB" sz="1400" spc="-2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luded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ime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int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en-GB" sz="1400" spc="-15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oup. C, citrate group; NC, non-citrate group.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46107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357C343-CF55-7DF4-14E0-6D2523BE99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496897" y="339460"/>
            <a:ext cx="8057134" cy="5770313"/>
          </a:xfrm>
          <a:prstGeom prst="rect">
            <a:avLst/>
          </a:prstGeom>
          <a:noFill/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D0E16F3-00E3-B274-12ED-6ECD7678C529}"/>
              </a:ext>
            </a:extLst>
          </p:cNvPr>
          <p:cNvSpPr txBox="1"/>
          <p:nvPr/>
        </p:nvSpPr>
        <p:spPr>
          <a:xfrm>
            <a:off x="580444" y="6109773"/>
            <a:ext cx="9911301" cy="4628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5:</a:t>
            </a:r>
            <a:r>
              <a:rPr lang="en-GB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Number of kidney stones observed after baseline in the citrate (C) and non-citrate (NC) group.</a:t>
            </a:r>
            <a:endParaRPr lang="de-CH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5391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4</Words>
  <Application>Microsoft Office PowerPoint</Application>
  <PresentationFormat>Breitbild</PresentationFormat>
  <Paragraphs>5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eger, Harald</dc:creator>
  <cp:lastModifiedBy>Seeger, Harald</cp:lastModifiedBy>
  <cp:revision>3</cp:revision>
  <dcterms:created xsi:type="dcterms:W3CDTF">2025-12-30T16:20:23Z</dcterms:created>
  <dcterms:modified xsi:type="dcterms:W3CDTF">2025-12-30T16:39:35Z</dcterms:modified>
</cp:coreProperties>
</file>